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SUS" initials="A" lastIdx="1" clrIdx="0">
    <p:extLst>
      <p:ext uri="{19B8F6BF-5375-455C-9EA6-DF929625EA0E}">
        <p15:presenceInfo xmlns:p15="http://schemas.microsoft.com/office/powerpoint/2012/main" userId="ASU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CC"/>
    <a:srgbClr val="FF66FF"/>
    <a:srgbClr val="1EC1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03BC9D-4DA1-4B32-A76D-DA49D9BCDF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91B04E8-91BF-4851-A584-475FF4AE73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0C4B0BC-CB8C-4558-AA1B-AF94F2190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96799C7-21B5-4319-9038-20C8DBF23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DC869D3-2055-4C17-96F5-B24120270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660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0631DCC-5498-4543-ACF6-D07C45EC8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6DAA737-65AC-4B07-A41B-495CACDB04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98B3B39-2828-4DDF-9ACB-719D2FB9E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75FF78E-E3B5-4BD9-8F7F-9CC29FE5E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38CAA88-BE7D-449F-8D03-708EAEEA7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364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EDD5129-5D6F-48A6-8315-7392B7156F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5BF870A-4C72-4D39-8BB5-C84EF2F1D1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BAB234B-74B1-4B60-B91A-94B6A6393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191E324-0867-45B9-8745-6E01A4BA5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961D139-9C86-4B3F-A64B-24B6DDF06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839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D04EB05-9DF8-448B-89B1-D0A47F114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0A82278-DD36-4C99-BAFB-810D7973C6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1443864-ACF6-4C29-98F0-59E04EF3F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4082E5-E3D4-4E79-8DC9-31DFA94A3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E477FD0-CE62-49E6-B7A8-C74CCBA22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9216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5DCDB0-D2F8-4189-B748-DBD06813C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074BF04-8315-46D3-9E35-F7228E05F4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ED0ABDB-3E66-40C3-8A9D-8F864B5B4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26854EA-B386-4FA1-98E0-EA5172085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00CF0A8-FB14-451B-A828-C6351926B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7026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E0BE45-95EE-44D7-B0ED-39C0F9F3D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3FFCF5-FF62-4D56-AD8F-059678EF02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E329997-8BA5-4143-9961-6A10698507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34DC390-E718-46E1-AEFC-56DE49B2B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D6463F-8701-48E3-9E6F-90E05BD1A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6EF53C5-BCD3-47AF-8897-27BA0320D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5843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22F400A-3A5F-4B31-9388-C82C572CE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981A23-62D1-4E60-ACF6-41F603567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46A957E-FEDB-4AA3-95BF-99BEC6634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1E7DFC7-2127-4157-A6C5-E9EBEB76AE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0F0E567-1C0D-4A1F-BE25-F45BB56CA1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4BF8334-A419-4B37-8992-ECECFFB6E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7173EAA0-335B-4608-B211-ADB76235A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00EB8DC-6E74-4577-A775-716501465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7635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4D08ABB-6C1E-483A-B670-BC4A5BB092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B682EC3-914A-469A-ADA5-0470F36FB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A494988-7EB2-4E96-BF17-445029502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98D0DAA-CCF8-4DC8-AF33-895BF52D6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5995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60B5D5D-9C08-4E4B-92F0-E4A764E5F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EA3C6EF-73D9-4062-81FD-EA97212E3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1E01E7FB-7182-4A3F-B8D4-5C686B272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950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6EBA90B-272F-4DB1-B14E-0FFB6E0CC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8698CEF-1251-4B57-BC81-DA850AB0F3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3B34C7D-70AB-455E-A098-5672B7FF9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28E4236-344C-4F16-BFF6-9DAA98C3D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0984857-2D03-43E6-88BA-22841210D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113E32D-6D1E-41AA-8364-9B95222C6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193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D2D2A7-606C-4AEF-AE9C-F4C8260AEF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8D7C07F-7872-4310-A0AB-3CF59DAD87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4EF1A32-4E1A-4481-91D0-5EDA64C926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3699493-7DA4-4007-BB90-DB6EF5FFE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32506A-3993-459E-9E2F-9F8DF3926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36E4346-AF3F-47A7-BFAA-3E38AC83A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8774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EA7DC01-CD5B-46B0-B19A-C72AC9AAD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A0AF39-6A3B-4F8C-9C31-102E58BD64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7108901-FB05-4D4B-A413-A83686B412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C08CC-10D0-4D75-B76F-2151002F5F1E}" type="datetimeFigureOut">
              <a:rPr lang="fr-FR" smtClean="0"/>
              <a:t>25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CBAB4A7-1880-4FD0-8009-165FC9FE74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1A901BD-E753-416F-8E18-E97115B9D4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2CEF0-DE75-454F-AB5C-BC9B5E3C8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9567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e 16">
            <a:extLst>
              <a:ext uri="{FF2B5EF4-FFF2-40B4-BE49-F238E27FC236}">
                <a16:creationId xmlns:a16="http://schemas.microsoft.com/office/drawing/2014/main" id="{D6973556-6A66-4AFE-9044-C4932E7739A4}"/>
              </a:ext>
            </a:extLst>
          </p:cNvPr>
          <p:cNvGrpSpPr/>
          <p:nvPr/>
        </p:nvGrpSpPr>
        <p:grpSpPr>
          <a:xfrm>
            <a:off x="3012952" y="1169311"/>
            <a:ext cx="6684721" cy="4333868"/>
            <a:chOff x="1990347" y="518616"/>
            <a:chExt cx="8078785" cy="5467558"/>
          </a:xfrm>
        </p:grpSpPr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48CB7B0C-BEEB-436C-BFE8-78BC680FF9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2015" t="17895" r="24888" b="14410"/>
            <a:stretch/>
          </p:blipFill>
          <p:spPr>
            <a:xfrm>
              <a:off x="2497540" y="518616"/>
              <a:ext cx="6892120" cy="4885898"/>
            </a:xfrm>
            <a:prstGeom prst="rect">
              <a:avLst/>
            </a:prstGeom>
          </p:spPr>
        </p:pic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5B0D0063-E5CC-405C-9969-6368EDB0E6A7}"/>
                </a:ext>
              </a:extLst>
            </p:cNvPr>
            <p:cNvGrpSpPr/>
            <p:nvPr/>
          </p:nvGrpSpPr>
          <p:grpSpPr>
            <a:xfrm>
              <a:off x="1990347" y="863415"/>
              <a:ext cx="8078785" cy="5122759"/>
              <a:chOff x="2085881" y="1456081"/>
              <a:chExt cx="8078785" cy="5122759"/>
            </a:xfrm>
          </p:grpSpPr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01144724-1C89-4374-A276-2EDDDA8D2ADA}"/>
                  </a:ext>
                </a:extLst>
              </p:cNvPr>
              <p:cNvSpPr txBox="1"/>
              <p:nvPr/>
            </p:nvSpPr>
            <p:spPr>
              <a:xfrm>
                <a:off x="2085881" y="1825413"/>
                <a:ext cx="181554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>
                    <a:solidFill>
                      <a:srgbClr val="FF99CC"/>
                    </a:solidFill>
                  </a:rPr>
                  <a:t>Group 2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0D774BB8-EF48-42ED-A9C2-2351110CD28A}"/>
                  </a:ext>
                </a:extLst>
              </p:cNvPr>
              <p:cNvSpPr txBox="1"/>
              <p:nvPr/>
            </p:nvSpPr>
            <p:spPr>
              <a:xfrm>
                <a:off x="5688742" y="6209508"/>
                <a:ext cx="18155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>
                    <a:solidFill>
                      <a:srgbClr val="92D050"/>
                    </a:solidFill>
                  </a:rPr>
                  <a:t>Group 3</a:t>
                </a:r>
              </a:p>
            </p:txBody>
          </p:sp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F12592C4-5470-420C-8E5C-620CEACC9CE2}"/>
                  </a:ext>
                </a:extLst>
              </p:cNvPr>
              <p:cNvSpPr txBox="1"/>
              <p:nvPr/>
            </p:nvSpPr>
            <p:spPr>
              <a:xfrm>
                <a:off x="8349118" y="1456081"/>
                <a:ext cx="18155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>
                    <a:solidFill>
                      <a:schemeClr val="accent1">
                        <a:lumMod val="60000"/>
                        <a:lumOff val="40000"/>
                      </a:schemeClr>
                    </a:solidFill>
                  </a:rPr>
                  <a:t>Group 1</a:t>
                </a:r>
              </a:p>
            </p:txBody>
          </p:sp>
        </p:grpSp>
      </p:grpSp>
      <p:sp>
        <p:nvSpPr>
          <p:cNvPr id="3" name="ZoneTexte 2"/>
          <p:cNvSpPr txBox="1"/>
          <p:nvPr/>
        </p:nvSpPr>
        <p:spPr>
          <a:xfrm>
            <a:off x="10452683" y="104503"/>
            <a:ext cx="1662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8648953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2109009C-8D1E-481B-A784-32B9B1160F06}"/>
              </a:ext>
            </a:extLst>
          </p:cNvPr>
          <p:cNvGrpSpPr/>
          <p:nvPr/>
        </p:nvGrpSpPr>
        <p:grpSpPr>
          <a:xfrm>
            <a:off x="461554" y="583476"/>
            <a:ext cx="10755086" cy="4994554"/>
            <a:chOff x="0" y="-2080590"/>
            <a:chExt cx="12192000" cy="10250554"/>
          </a:xfrm>
        </p:grpSpPr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18B981CC-0680-441F-85E7-471D67E47117}"/>
                </a:ext>
              </a:extLst>
            </p:cNvPr>
            <p:cNvGrpSpPr/>
            <p:nvPr/>
          </p:nvGrpSpPr>
          <p:grpSpPr>
            <a:xfrm>
              <a:off x="0" y="-2080590"/>
              <a:ext cx="12192000" cy="8503567"/>
              <a:chOff x="0" y="13252"/>
              <a:chExt cx="12192000" cy="8503567"/>
            </a:xfrm>
          </p:grpSpPr>
          <p:pic>
            <p:nvPicPr>
              <p:cNvPr id="7" name="Image 6">
                <a:extLst>
                  <a:ext uri="{FF2B5EF4-FFF2-40B4-BE49-F238E27FC236}">
                    <a16:creationId xmlns:a16="http://schemas.microsoft.com/office/drawing/2014/main" id="{B4548382-2E5B-4040-B322-7B17E478F9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0" y="13252"/>
                <a:ext cx="12192000" cy="1619041"/>
              </a:xfrm>
              <a:prstGeom prst="rect">
                <a:avLst/>
              </a:prstGeom>
            </p:spPr>
          </p:pic>
          <p:pic>
            <p:nvPicPr>
              <p:cNvPr id="8" name="Image 7">
                <a:extLst>
                  <a:ext uri="{FF2B5EF4-FFF2-40B4-BE49-F238E27FC236}">
                    <a16:creationId xmlns:a16="http://schemas.microsoft.com/office/drawing/2014/main" id="{EB439D61-1DD2-4556-8E15-1B3C9D03D0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0" y="1738309"/>
                <a:ext cx="12192000" cy="1641231"/>
              </a:xfrm>
              <a:prstGeom prst="rect">
                <a:avLst/>
              </a:prstGeom>
            </p:spPr>
          </p:pic>
          <p:pic>
            <p:nvPicPr>
              <p:cNvPr id="9" name="Image 8">
                <a:extLst>
                  <a:ext uri="{FF2B5EF4-FFF2-40B4-BE49-F238E27FC236}">
                    <a16:creationId xmlns:a16="http://schemas.microsoft.com/office/drawing/2014/main" id="{76601AE7-B053-427E-902D-103D0008B4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0" y="3445800"/>
                <a:ext cx="12192000" cy="1632213"/>
              </a:xfrm>
              <a:prstGeom prst="rect">
                <a:avLst/>
              </a:prstGeom>
            </p:spPr>
          </p:pic>
          <p:pic>
            <p:nvPicPr>
              <p:cNvPr id="10" name="Image 9">
                <a:extLst>
                  <a:ext uri="{FF2B5EF4-FFF2-40B4-BE49-F238E27FC236}">
                    <a16:creationId xmlns:a16="http://schemas.microsoft.com/office/drawing/2014/main" id="{0BACF13C-B8BE-466E-82DE-D355BD6FA0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0" y="5150359"/>
                <a:ext cx="12192000" cy="1619601"/>
              </a:xfrm>
              <a:prstGeom prst="rect">
                <a:avLst/>
              </a:prstGeom>
            </p:spPr>
          </p:pic>
          <p:pic>
            <p:nvPicPr>
              <p:cNvPr id="11" name="Image 10">
                <a:extLst>
                  <a:ext uri="{FF2B5EF4-FFF2-40B4-BE49-F238E27FC236}">
                    <a16:creationId xmlns:a16="http://schemas.microsoft.com/office/drawing/2014/main" id="{17498520-B447-451D-A869-4607925583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0" y="6875588"/>
                <a:ext cx="12192000" cy="1641231"/>
              </a:xfrm>
              <a:prstGeom prst="rect">
                <a:avLst/>
              </a:prstGeom>
            </p:spPr>
          </p:pic>
        </p:grpSp>
        <p:grpSp>
          <p:nvGrpSpPr>
            <p:cNvPr id="4" name="Groupe 3">
              <a:extLst>
                <a:ext uri="{FF2B5EF4-FFF2-40B4-BE49-F238E27FC236}">
                  <a16:creationId xmlns:a16="http://schemas.microsoft.com/office/drawing/2014/main" id="{54229671-A570-474B-8CAF-FB20E7E82B20}"/>
                </a:ext>
              </a:extLst>
            </p:cNvPr>
            <p:cNvGrpSpPr/>
            <p:nvPr/>
          </p:nvGrpSpPr>
          <p:grpSpPr>
            <a:xfrm>
              <a:off x="7" y="6523863"/>
              <a:ext cx="5314119" cy="1646101"/>
              <a:chOff x="6877880" y="2605949"/>
              <a:chExt cx="5314119" cy="1646101"/>
            </a:xfrm>
          </p:grpSpPr>
          <p:pic>
            <p:nvPicPr>
              <p:cNvPr id="5" name="Image 4">
                <a:extLst>
                  <a:ext uri="{FF2B5EF4-FFF2-40B4-BE49-F238E27FC236}">
                    <a16:creationId xmlns:a16="http://schemas.microsoft.com/office/drawing/2014/main" id="{9ED07AC7-7070-4516-97A4-CB119B83AD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64130"/>
              <a:stretch/>
            </p:blipFill>
            <p:spPr>
              <a:xfrm>
                <a:off x="7818782" y="2605949"/>
                <a:ext cx="4373217" cy="1646101"/>
              </a:xfrm>
              <a:prstGeom prst="rect">
                <a:avLst/>
              </a:prstGeom>
            </p:spPr>
          </p:pic>
          <p:pic>
            <p:nvPicPr>
              <p:cNvPr id="6" name="Image 5">
                <a:extLst>
                  <a:ext uri="{FF2B5EF4-FFF2-40B4-BE49-F238E27FC236}">
                    <a16:creationId xmlns:a16="http://schemas.microsoft.com/office/drawing/2014/main" id="{BD66F43E-8B85-488A-BEB7-035BB073CB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r="92283"/>
              <a:stretch/>
            </p:blipFill>
            <p:spPr>
              <a:xfrm>
                <a:off x="6877880" y="2605949"/>
                <a:ext cx="940904" cy="1646101"/>
              </a:xfrm>
              <a:prstGeom prst="rect">
                <a:avLst/>
              </a:prstGeom>
            </p:spPr>
          </p:pic>
        </p:grpSp>
      </p:grpSp>
      <p:sp>
        <p:nvSpPr>
          <p:cNvPr id="12" name="ZoneTexte 11">
            <a:extLst>
              <a:ext uri="{FF2B5EF4-FFF2-40B4-BE49-F238E27FC236}">
                <a16:creationId xmlns:a16="http://schemas.microsoft.com/office/drawing/2014/main" id="{39D1B923-EA02-40C5-AC67-83C659020754}"/>
              </a:ext>
            </a:extLst>
          </p:cNvPr>
          <p:cNvSpPr txBox="1"/>
          <p:nvPr/>
        </p:nvSpPr>
        <p:spPr>
          <a:xfrm>
            <a:off x="10345783" y="104503"/>
            <a:ext cx="17691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4218656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A7449EAC-9BB1-4595-AFE4-52BBDD6A8CD1}"/>
              </a:ext>
            </a:extLst>
          </p:cNvPr>
          <p:cNvGrpSpPr/>
          <p:nvPr/>
        </p:nvGrpSpPr>
        <p:grpSpPr>
          <a:xfrm>
            <a:off x="123265" y="344257"/>
            <a:ext cx="10263611" cy="5708005"/>
            <a:chOff x="123265" y="370890"/>
            <a:chExt cx="10263611" cy="5708005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E1199C8D-FA5A-403F-8A66-5D89482547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4214" r="50000" b="45179"/>
            <a:stretch/>
          </p:blipFill>
          <p:spPr>
            <a:xfrm>
              <a:off x="123265" y="564863"/>
              <a:ext cx="4758434" cy="740742"/>
            </a:xfrm>
            <a:prstGeom prst="rect">
              <a:avLst/>
            </a:prstGeom>
          </p:spPr>
        </p:pic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1D22BD1E-C150-45D2-A896-3DE329B2D8C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728" t="44656" r="50000" b="45713"/>
            <a:stretch/>
          </p:blipFill>
          <p:spPr>
            <a:xfrm>
              <a:off x="123265" y="1744669"/>
              <a:ext cx="4754880" cy="740664"/>
            </a:xfrm>
            <a:prstGeom prst="rect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45AA0B81-638C-45A4-9FEA-A6E1FD2D175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t="20903" r="50704" b="68302"/>
            <a:stretch/>
          </p:blipFill>
          <p:spPr>
            <a:xfrm>
              <a:off x="123265" y="4159743"/>
              <a:ext cx="4754880" cy="740664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7261C311-1DBB-457C-86F2-57327AC721F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/>
            <a:srcRect l="874" t="40565" r="50000" b="49603"/>
            <a:stretch/>
          </p:blipFill>
          <p:spPr>
            <a:xfrm>
              <a:off x="5628442" y="564863"/>
              <a:ext cx="4758434" cy="740664"/>
            </a:xfrm>
            <a:prstGeom prst="rect">
              <a:avLst/>
            </a:prstGeom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738CC1E0-115D-4E76-A056-CCC55F17A93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/>
            <a:srcRect l="1237" t="32184" r="51288" b="56792"/>
            <a:stretch/>
          </p:blipFill>
          <p:spPr>
            <a:xfrm>
              <a:off x="5628442" y="2933276"/>
              <a:ext cx="4754880" cy="740664"/>
            </a:xfrm>
            <a:prstGeom prst="rect">
              <a:avLst/>
            </a:prstGeom>
          </p:spPr>
        </p:pic>
        <p:pic>
          <p:nvPicPr>
            <p:cNvPr id="8" name="Image 7">
              <a:extLst>
                <a:ext uri="{FF2B5EF4-FFF2-40B4-BE49-F238E27FC236}">
                  <a16:creationId xmlns:a16="http://schemas.microsoft.com/office/drawing/2014/main" id="{AD6D5D9B-D9BF-47EC-B355-164C3B3C5CF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/>
            <a:srcRect l="582" t="21824" r="51141" b="68310"/>
            <a:stretch/>
          </p:blipFill>
          <p:spPr>
            <a:xfrm>
              <a:off x="5628442" y="4159743"/>
              <a:ext cx="4754880" cy="740664"/>
            </a:xfrm>
            <a:prstGeom prst="rect">
              <a:avLst/>
            </a:prstGeom>
          </p:spPr>
        </p:pic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FC2D34C1-9B89-47B4-9AA7-F5E3BD9B797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/>
            <a:srcRect l="656" t="55405" r="50921" b="33507"/>
            <a:stretch/>
          </p:blipFill>
          <p:spPr>
            <a:xfrm>
              <a:off x="5628442" y="5338231"/>
              <a:ext cx="4754880" cy="740664"/>
            </a:xfrm>
            <a:prstGeom prst="rect">
              <a:avLst/>
            </a:prstGeom>
          </p:spPr>
        </p:pic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92E4B846-A1B9-4DBB-945F-534317505BF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/>
            <a:srcRect l="-234" t="40268" r="50978" b="48953"/>
            <a:stretch/>
          </p:blipFill>
          <p:spPr>
            <a:xfrm>
              <a:off x="123265" y="2933276"/>
              <a:ext cx="4754880" cy="736135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7E05EB3D-BAF4-44B1-B3ED-FD6B0FC9ACC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/>
            <a:srcRect l="695" t="49753" r="50972" b="39260"/>
            <a:stretch/>
          </p:blipFill>
          <p:spPr>
            <a:xfrm>
              <a:off x="123265" y="5338231"/>
              <a:ext cx="4754880" cy="740664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BE1D3112-6CC3-49D2-9427-AE67461B1C6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1"/>
            <a:srcRect l="1042" t="40000" r="51041" b="50428"/>
            <a:stretch/>
          </p:blipFill>
          <p:spPr>
            <a:xfrm>
              <a:off x="5628442" y="1744669"/>
              <a:ext cx="4754880" cy="740664"/>
            </a:xfrm>
            <a:prstGeom prst="rect">
              <a:avLst/>
            </a:prstGeom>
          </p:spPr>
        </p:pic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79B099B-265A-4EA9-8244-49354265C0C0}"/>
                </a:ext>
              </a:extLst>
            </p:cNvPr>
            <p:cNvSpPr txBox="1"/>
            <p:nvPr/>
          </p:nvSpPr>
          <p:spPr>
            <a:xfrm>
              <a:off x="239693" y="407834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1: 492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B2437FDA-345C-459F-BA32-6D30138554CF}"/>
                </a:ext>
              </a:extLst>
            </p:cNvPr>
            <p:cNvSpPr txBox="1"/>
            <p:nvPr/>
          </p:nvSpPr>
          <p:spPr>
            <a:xfrm>
              <a:off x="239693" y="1571106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2: 501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4FA7BC5B-1F88-49F7-9FEF-D78E03AE8300}"/>
                </a:ext>
              </a:extLst>
            </p:cNvPr>
            <p:cNvSpPr txBox="1"/>
            <p:nvPr/>
          </p:nvSpPr>
          <p:spPr>
            <a:xfrm>
              <a:off x="239693" y="4012660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4: 496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7876C672-8BAB-4DA9-AC53-806505059810}"/>
                </a:ext>
              </a:extLst>
            </p:cNvPr>
            <p:cNvSpPr txBox="1"/>
            <p:nvPr/>
          </p:nvSpPr>
          <p:spPr>
            <a:xfrm>
              <a:off x="239693" y="2776996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3: 546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id="{F10A476E-D02E-41BA-9DA9-B7CF79AD5CDF}"/>
                </a:ext>
              </a:extLst>
            </p:cNvPr>
            <p:cNvSpPr txBox="1"/>
            <p:nvPr/>
          </p:nvSpPr>
          <p:spPr>
            <a:xfrm>
              <a:off x="239693" y="5214725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5: 539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EF1AE961-F55E-48ED-9D02-68005A988170}"/>
                </a:ext>
              </a:extLst>
            </p:cNvPr>
            <p:cNvSpPr txBox="1"/>
            <p:nvPr/>
          </p:nvSpPr>
          <p:spPr>
            <a:xfrm>
              <a:off x="5758676" y="370890"/>
              <a:ext cx="27615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6: 460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DDC18EAA-F027-4101-8B6B-3004EE21017E}"/>
                </a:ext>
              </a:extLst>
            </p:cNvPr>
            <p:cNvSpPr txBox="1"/>
            <p:nvPr/>
          </p:nvSpPr>
          <p:spPr>
            <a:xfrm>
              <a:off x="5758676" y="2821744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8: 494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1C173374-77D5-4BF4-AFD0-CBD83B7B6B75}"/>
                </a:ext>
              </a:extLst>
            </p:cNvPr>
            <p:cNvSpPr txBox="1"/>
            <p:nvPr/>
          </p:nvSpPr>
          <p:spPr>
            <a:xfrm>
              <a:off x="5758676" y="3950129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9:  494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2A9EE4CA-BE63-415D-99F9-E59A720F09FA}"/>
                </a:ext>
              </a:extLst>
            </p:cNvPr>
            <p:cNvSpPr txBox="1"/>
            <p:nvPr/>
          </p:nvSpPr>
          <p:spPr>
            <a:xfrm>
              <a:off x="5758676" y="5208529"/>
              <a:ext cx="2556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10:  494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EFA5D645-AF8A-4DF0-9911-4C3929885358}"/>
                </a:ext>
              </a:extLst>
            </p:cNvPr>
            <p:cNvSpPr txBox="1"/>
            <p:nvPr/>
          </p:nvSpPr>
          <p:spPr>
            <a:xfrm>
              <a:off x="5758676" y="1572145"/>
              <a:ext cx="27615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vCAT7: 533 </a:t>
              </a:r>
              <a:r>
                <a:rPr lang="fr-FR" sz="1000" b="1" dirty="0" err="1">
                  <a:latin typeface="Palatino Linotype" panose="02040502050505030304" pitchFamily="18" charset="0"/>
                  <a:cs typeface="Arial" panose="020B0604020202020204" pitchFamily="34" charset="0"/>
                </a:rPr>
                <a:t>aa</a:t>
              </a:r>
              <a:endParaRPr lang="fr-FR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id="{3D4D4713-A886-4E6D-8DA1-4104CAA9D3CA}"/>
              </a:ext>
            </a:extLst>
          </p:cNvPr>
          <p:cNvSpPr txBox="1"/>
          <p:nvPr/>
        </p:nvSpPr>
        <p:spPr>
          <a:xfrm>
            <a:off x="10271464" y="104503"/>
            <a:ext cx="18434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2990783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74</TotalTime>
  <Words>52</Words>
  <Application>Microsoft Office PowerPoint</Application>
  <PresentationFormat>Grand écran</PresentationFormat>
  <Paragraphs>1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SUS</dc:creator>
  <cp:lastModifiedBy>Faical Brini</cp:lastModifiedBy>
  <cp:revision>50</cp:revision>
  <dcterms:created xsi:type="dcterms:W3CDTF">2023-06-18T14:03:17Z</dcterms:created>
  <dcterms:modified xsi:type="dcterms:W3CDTF">2023-09-25T10:08:39Z</dcterms:modified>
</cp:coreProperties>
</file>